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1" r:id="rId2"/>
  </p:sldIdLst>
  <p:sldSz cx="6858000" cy="9906000" type="A4"/>
  <p:notesSz cx="6797675" cy="9926638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33"/>
    <a:srgbClr val="008000"/>
    <a:srgbClr val="00FF00"/>
    <a:srgbClr val="00CC66"/>
    <a:srgbClr val="CCFFCC"/>
    <a:srgbClr val="FF3300"/>
    <a:srgbClr val="C0EB2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 autoAdjust="0"/>
    <p:restoredTop sz="94660"/>
  </p:normalViewPr>
  <p:slideViewPr>
    <p:cSldViewPr>
      <p:cViewPr varScale="1">
        <p:scale>
          <a:sx n="86" d="100"/>
          <a:sy n="86" d="100"/>
        </p:scale>
        <p:origin x="4112" y="20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>
      <p:cViewPr varScale="1">
        <p:scale>
          <a:sx n="82" d="100"/>
          <a:sy n="82" d="100"/>
        </p:scale>
        <p:origin x="4008" y="17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2EC41C-C8A5-4F22-B334-D419747501CE}" type="datetimeFigureOut">
              <a:rPr lang="en-US" smtClean="0"/>
              <a:t>10/5/21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0B90B2-AF2A-4811-B0CE-B512053F9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6344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693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16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845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982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328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95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269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787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737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522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567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209C4-1D9A-409A-99FF-B79133C06396}" type="datetimeFigureOut">
              <a:rPr lang="en-US" smtClean="0"/>
              <a:t>10/5/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F5921-5E08-4F37-9064-EFD50D3957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449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8074AC3E-5BB3-5C46-9496-3C57FC3FE3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8342400"/>
              </p:ext>
            </p:extLst>
          </p:nvPr>
        </p:nvGraphicFramePr>
        <p:xfrm>
          <a:off x="195486" y="992560"/>
          <a:ext cx="6467027" cy="60689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40">
                  <a:extLst>
                    <a:ext uri="{9D8B030D-6E8A-4147-A177-3AD203B41FA5}">
                      <a16:colId xmlns:a16="http://schemas.microsoft.com/office/drawing/2014/main" val="2799639308"/>
                    </a:ext>
                  </a:extLst>
                </a:gridCol>
                <a:gridCol w="1296144">
                  <a:extLst>
                    <a:ext uri="{9D8B030D-6E8A-4147-A177-3AD203B41FA5}">
                      <a16:colId xmlns:a16="http://schemas.microsoft.com/office/drawing/2014/main" val="3368064780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1300609308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2301136995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44218795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1154324535"/>
                    </a:ext>
                  </a:extLst>
                </a:gridCol>
                <a:gridCol w="792088">
                  <a:extLst>
                    <a:ext uri="{9D8B030D-6E8A-4147-A177-3AD203B41FA5}">
                      <a16:colId xmlns:a16="http://schemas.microsoft.com/office/drawing/2014/main" val="1432625356"/>
                    </a:ext>
                  </a:extLst>
                </a:gridCol>
                <a:gridCol w="792088">
                  <a:extLst>
                    <a:ext uri="{9D8B030D-6E8A-4147-A177-3AD203B41FA5}">
                      <a16:colId xmlns:a16="http://schemas.microsoft.com/office/drawing/2014/main" val="233719625"/>
                    </a:ext>
                  </a:extLst>
                </a:gridCol>
                <a:gridCol w="922411">
                  <a:extLst>
                    <a:ext uri="{9D8B030D-6E8A-4147-A177-3AD203B41FA5}">
                      <a16:colId xmlns:a16="http://schemas.microsoft.com/office/drawing/2014/main" val="1329302921"/>
                    </a:ext>
                  </a:extLst>
                </a:gridCol>
              </a:tblGrid>
              <a:tr h="290323">
                <a:tc>
                  <a:txBody>
                    <a:bodyPr/>
                    <a:lstStyle/>
                    <a:p>
                      <a:pPr algn="ctr"/>
                      <a:endParaRPr lang="en-US" altLang="zh-CN" sz="900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bodi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Hos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Clon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fluorochrom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Dilut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Sourc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/>
                        <a:t>Identifier</a:t>
                      </a:r>
                      <a:endParaRPr lang="en-US" altLang="zh-CN" sz="900" noProof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alysi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26186766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KI-6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Lab Vi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9106f50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71624779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cardiac troponin 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u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ol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4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Therm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S-295-P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52850266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cardiac troponin 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4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c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459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22084654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RunX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ol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c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9233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9759198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Nkx2.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ol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Santa Cruz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SC-140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26087275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TEAD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CellSignaling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3295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19369130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cardiac </a:t>
                      </a:r>
                      <a:r>
                        <a:rPr lang="en-US" altLang="zh-CN" sz="900" noProof="0" dirty="0">
                          <a:latin typeface="Symbol" pitchFamily="2" charset="2"/>
                        </a:rPr>
                        <a:t>a</a:t>
                      </a:r>
                      <a:r>
                        <a:rPr lang="en-US" altLang="zh-CN" sz="900" noProof="0" dirty="0"/>
                        <a:t>-actini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u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ol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Therm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26M281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42370320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Aurora B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c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4514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01698913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pH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:4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erck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H04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88648632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Vimenti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ol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:4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c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13732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83655338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WT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u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:4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Santa Cruz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SC-738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43983775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Isl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c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1784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24752227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Tbx1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ol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c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11526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3122389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GATA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ol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:4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Santa Cruz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SC-253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45801681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IL-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b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:4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c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23370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51254705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mouse IgG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goa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ol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FITC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c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9705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05455185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rabbit IgG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goa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ol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TRITC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:4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bc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yb671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Histolog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55077691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1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CD4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1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Biolege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0310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Flow Cytometr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92860261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nti-CD4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PC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1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eBioscienc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7-0441-8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Flow Cytometr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69663755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2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CD7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Fisher Sci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526858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Flow Cytometr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89390860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2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CD9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Biolege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0530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Flow Cytometr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59728429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CD10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P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Biolege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2040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Flow Cytometr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78962715"/>
                  </a:ext>
                </a:extLst>
              </a:tr>
              <a:tr h="24796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2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anti-flk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ra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mo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APC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:1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Biolege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noProof="0" dirty="0"/>
                        <a:t>13640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noProof="0" dirty="0"/>
                        <a:t>Flow Cytometry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650776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98975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69</TotalTime>
  <Words>234</Words>
  <Application>Microsoft Macintosh PowerPoint</Application>
  <PresentationFormat>A4 纸张(210x297 毫米)</PresentationFormat>
  <Paragraphs>21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主题​​</vt:lpstr>
      <vt:lpstr>PowerPoint 演示文稿</vt:lpstr>
    </vt:vector>
  </TitlesOfParts>
  <Manager/>
  <Company>HHU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subject/>
  <dc:creator>ding</dc:creator>
  <cp:keywords/>
  <dc:description/>
  <cp:lastModifiedBy>Zhaoping Ding</cp:lastModifiedBy>
  <cp:revision>446</cp:revision>
  <cp:lastPrinted>2019-08-05T07:14:51Z</cp:lastPrinted>
  <dcterms:created xsi:type="dcterms:W3CDTF">2013-12-17T15:42:53Z</dcterms:created>
  <dcterms:modified xsi:type="dcterms:W3CDTF">2021-10-05T06:45:35Z</dcterms:modified>
  <cp:category/>
</cp:coreProperties>
</file>